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2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howGuides="1">
      <p:cViewPr varScale="1">
        <p:scale>
          <a:sx n="76" d="100"/>
          <a:sy n="76" d="100"/>
        </p:scale>
        <p:origin x="878" y="53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5D25A8B-223B-481D-B09A-9F880CE3E1A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B0EE0DB3-04A2-4518-A2A7-7855F813E41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CB6A984-DFEF-4F46-8433-FA8120EE85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FA428-AC50-42BA-9A62-DAD27B84634E}" type="datetimeFigureOut">
              <a:rPr lang="zh-CN" altLang="en-US" smtClean="0"/>
              <a:t>2024/1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B0788E0-2A1F-401F-8AEC-9AEECBD694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10DE079-3C1D-4194-8228-64D437D998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A609E-7829-4B08-AE32-934904BF2C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821474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8D496BF-135F-4A2A-8333-D47593A5DC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33A1B39-CF65-4EFC-80F4-C8E18AE3A49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2B67FBD-D37E-4C10-BCAE-731C438F05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FA428-AC50-42BA-9A62-DAD27B84634E}" type="datetimeFigureOut">
              <a:rPr lang="zh-CN" altLang="en-US" smtClean="0"/>
              <a:t>2024/1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9F90F9E-BA89-4AA1-822D-E80F3DDBE9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FAF52B1-31B1-4D10-996E-5E5677831B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A609E-7829-4B08-AE32-934904BF2C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91934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38B2D9C5-5371-41E0-A511-D67384FFDB9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0FE6133-DAEB-465B-8C9A-361C8806EF3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C5701FD-4796-4F76-9144-2F080D9669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FA428-AC50-42BA-9A62-DAD27B84634E}" type="datetimeFigureOut">
              <a:rPr lang="zh-CN" altLang="en-US" smtClean="0"/>
              <a:t>2024/1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49EFDEE-2A8D-4748-9160-953E6C8654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2C863CD-B3DA-41EB-B9C6-E4AA8B8147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A609E-7829-4B08-AE32-934904BF2C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896308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09326CD-5BD2-4D51-ACC6-A21DB82B00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EAED545-3831-48A2-B6A6-4E36AC57258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DDADDCC-35E1-4EA4-BF94-7897811F22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FA428-AC50-42BA-9A62-DAD27B84634E}" type="datetimeFigureOut">
              <a:rPr lang="zh-CN" altLang="en-US" smtClean="0"/>
              <a:t>2024/1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C202BF3-2172-46C0-A3FB-9B7317BF21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9E92A98-DB14-4730-8E99-3C647E528B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A609E-7829-4B08-AE32-934904BF2C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60074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5BFE8B8-564D-48EB-A166-9F4E4799F9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34533CD-1B3B-492D-A376-4835435746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3D8D800-457D-432B-B923-9FAC1DA305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FA428-AC50-42BA-9A62-DAD27B84634E}" type="datetimeFigureOut">
              <a:rPr lang="zh-CN" altLang="en-US" smtClean="0"/>
              <a:t>2024/1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2EF3778-AA80-4CF8-8119-114BBA49F7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49912C0-0221-4420-9FE8-30CA057D2E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A609E-7829-4B08-AE32-934904BF2C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880298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1C96A09-1841-4873-A24F-99328AFB17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9F2E29F-88A1-4574-83AD-F7F1AD6F5C1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20287DE-BEAD-42BC-8389-4FFAED4394A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E20C305-E8E6-4776-AF15-300E094118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FA428-AC50-42BA-9A62-DAD27B84634E}" type="datetimeFigureOut">
              <a:rPr lang="zh-CN" altLang="en-US" smtClean="0"/>
              <a:t>2024/1/1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E368D8B-5E76-4F24-9B60-36C27FD785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464E38F-6B43-4121-A959-73335418C6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A609E-7829-4B08-AE32-934904BF2C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5374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48C4B98-61FE-46D7-995F-67C70C6008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EAF945B-AA1E-4E78-A2ED-58526A93CD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F7A09EF-57AE-4E9B-BFE5-0240FDCB046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1CC6A005-AD71-4B7F-9E4F-546B9E7388A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A043AF22-7C86-45AD-8E68-872D3BFD700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0A0AD231-4497-4572-A2E0-31A1E778A5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FA428-AC50-42BA-9A62-DAD27B84634E}" type="datetimeFigureOut">
              <a:rPr lang="zh-CN" altLang="en-US" smtClean="0"/>
              <a:t>2024/1/10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9BD23201-0F3C-44B8-BD5A-B6AD854258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FBCC7400-6C64-4F17-B620-19F6A33AA7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A609E-7829-4B08-AE32-934904BF2C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12671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0EA9080-8A02-4435-877D-681F5955F9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64855D30-6521-4663-BD77-4151DECDF4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FA428-AC50-42BA-9A62-DAD27B84634E}" type="datetimeFigureOut">
              <a:rPr lang="zh-CN" altLang="en-US" smtClean="0"/>
              <a:t>2024/1/10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80FB38D1-52EB-40C8-AC30-966A39477D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1322AB01-F455-4B47-9326-31C540F5D7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A609E-7829-4B08-AE32-934904BF2C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785443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C64F73E4-46C9-42B3-874D-BA74782443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FA428-AC50-42BA-9A62-DAD27B84634E}" type="datetimeFigureOut">
              <a:rPr lang="zh-CN" altLang="en-US" smtClean="0"/>
              <a:t>2024/1/10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ADE0FF37-A36B-4F00-9470-8AA7FC1255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10661E6C-E592-459B-96D2-DC1A056DB7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A609E-7829-4B08-AE32-934904BF2C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115710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6E4B2D6-21E4-4A3F-B55D-77A9497061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59B77A5-AC0A-4449-91CA-D79372DE902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FAD4AF1-BFF3-4451-99B4-2481C445B31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4647F19-0CE2-4C6D-B685-E90FA3809A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FA428-AC50-42BA-9A62-DAD27B84634E}" type="datetimeFigureOut">
              <a:rPr lang="zh-CN" altLang="en-US" smtClean="0"/>
              <a:t>2024/1/1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4F5F28F-5555-45F7-85C8-7F7337E9E2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8CB4FD7-BC2F-4546-88A3-2C29DCA774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A609E-7829-4B08-AE32-934904BF2C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939588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3816D9E-8598-43F9-9C38-7615A22C11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6AB503A3-C249-426C-B0FD-47E32AEB1FF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4211D30-3B5C-4F19-BE7A-9D4E30C4D6B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6827920-BE91-4A08-B203-939E3ECE9E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FA428-AC50-42BA-9A62-DAD27B84634E}" type="datetimeFigureOut">
              <a:rPr lang="zh-CN" altLang="en-US" smtClean="0"/>
              <a:t>2024/1/1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511A685-9F73-42EB-9287-A2C2C23699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47F3148-4FFB-4C90-84CA-367BFFBBB8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A609E-7829-4B08-AE32-934904BF2C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06954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159947D6-7132-4F41-B37D-71F480AF68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2E5D9F0-CF2A-4730-8FB0-36A8D84BC0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8BFECE6-6B84-4237-987B-F9CBDB930FF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9FA428-AC50-42BA-9A62-DAD27B84634E}" type="datetimeFigureOut">
              <a:rPr lang="zh-CN" altLang="en-US" smtClean="0"/>
              <a:t>2024/1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D243B81-9A5E-4AF1-B016-7FBDC3A7074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5F6B8B6-17ED-4BD6-A2DD-F296B69B73D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1A609E-7829-4B08-AE32-934904BF2C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38524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DB9682F-C593-4750-AA99-B832BCEB190F}"/>
              </a:ext>
            </a:extLst>
          </p:cNvPr>
          <p:cNvSpPr txBox="1"/>
          <p:nvPr/>
        </p:nvSpPr>
        <p:spPr>
          <a:xfrm>
            <a:off x="37954" y="91078"/>
            <a:ext cx="13546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6A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DE1E7A9B-477C-4468-B686-69D8EDC1473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136486" y="1669616"/>
            <a:ext cx="5290120" cy="3518767"/>
          </a:xfrm>
          <a:prstGeom prst="rect">
            <a:avLst/>
          </a:prstGeom>
        </p:spPr>
      </p:pic>
      <p:sp>
        <p:nvSpPr>
          <p:cNvPr id="18" name="文本框 17">
            <a:extLst>
              <a:ext uri="{FF2B5EF4-FFF2-40B4-BE49-F238E27FC236}">
                <a16:creationId xmlns:a16="http://schemas.microsoft.com/office/drawing/2014/main" id="{3148D848-7D8E-435D-934A-A0EE30415094}"/>
              </a:ext>
            </a:extLst>
          </p:cNvPr>
          <p:cNvSpPr txBox="1"/>
          <p:nvPr/>
        </p:nvSpPr>
        <p:spPr>
          <a:xfrm>
            <a:off x="364067" y="2190152"/>
            <a:ext cx="276822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-125b  mimics +p65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A80CADDE-071C-4E9C-A62D-9EB95DC0F748}"/>
              </a:ext>
            </a:extLst>
          </p:cNvPr>
          <p:cNvSpPr txBox="1"/>
          <p:nvPr/>
        </p:nvSpPr>
        <p:spPr>
          <a:xfrm>
            <a:off x="364067" y="4113851"/>
            <a:ext cx="31506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iR-125b  mimics +Vector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AEC54477-2895-C41A-9866-3E7C7FAC9F91}"/>
              </a:ext>
            </a:extLst>
          </p:cNvPr>
          <p:cNvSpPr txBox="1"/>
          <p:nvPr/>
        </p:nvSpPr>
        <p:spPr>
          <a:xfrm>
            <a:off x="3132287" y="1231043"/>
            <a:ext cx="15785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eat 1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52E3F7EA-9088-D8EF-1250-DC1BC5F7C294}"/>
              </a:ext>
            </a:extLst>
          </p:cNvPr>
          <p:cNvSpPr txBox="1"/>
          <p:nvPr/>
        </p:nvSpPr>
        <p:spPr>
          <a:xfrm>
            <a:off x="4992274" y="1231043"/>
            <a:ext cx="15785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eat 2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98BDC37F-D6D7-F7B5-3DD0-5F7EC6D7C0D8}"/>
              </a:ext>
            </a:extLst>
          </p:cNvPr>
          <p:cNvSpPr txBox="1"/>
          <p:nvPr/>
        </p:nvSpPr>
        <p:spPr>
          <a:xfrm>
            <a:off x="6750735" y="1231043"/>
            <a:ext cx="15785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eat 3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3A27AFA3-F95D-A0C2-2F4C-17C158DD8B66}"/>
              </a:ext>
            </a:extLst>
          </p:cNvPr>
          <p:cNvSpPr txBox="1"/>
          <p:nvPr/>
        </p:nvSpPr>
        <p:spPr>
          <a:xfrm>
            <a:off x="3229614" y="5257625"/>
            <a:ext cx="15785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eat 1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DAA4C2C7-BD71-7BB9-80CB-F36B63184E78}"/>
              </a:ext>
            </a:extLst>
          </p:cNvPr>
          <p:cNvSpPr txBox="1"/>
          <p:nvPr/>
        </p:nvSpPr>
        <p:spPr>
          <a:xfrm>
            <a:off x="5089601" y="5257625"/>
            <a:ext cx="15785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eat 2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9BABDB0E-E435-4113-2D52-14798968EDB5}"/>
              </a:ext>
            </a:extLst>
          </p:cNvPr>
          <p:cNvSpPr txBox="1"/>
          <p:nvPr/>
        </p:nvSpPr>
        <p:spPr>
          <a:xfrm>
            <a:off x="6848062" y="5257625"/>
            <a:ext cx="15785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eat 3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85196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DB9682F-C593-4750-AA99-B832BCEB190F}"/>
              </a:ext>
            </a:extLst>
          </p:cNvPr>
          <p:cNvSpPr txBox="1"/>
          <p:nvPr/>
        </p:nvSpPr>
        <p:spPr>
          <a:xfrm>
            <a:off x="37954" y="91078"/>
            <a:ext cx="13546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6A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DE1E7A9B-477C-4468-B686-69D8EDC1473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212588" y="1669616"/>
            <a:ext cx="5137916" cy="3518767"/>
          </a:xfrm>
          <a:prstGeom prst="rect">
            <a:avLst/>
          </a:prstGeom>
        </p:spPr>
      </p:pic>
      <p:sp>
        <p:nvSpPr>
          <p:cNvPr id="18" name="文本框 17">
            <a:extLst>
              <a:ext uri="{FF2B5EF4-FFF2-40B4-BE49-F238E27FC236}">
                <a16:creationId xmlns:a16="http://schemas.microsoft.com/office/drawing/2014/main" id="{3148D848-7D8E-435D-934A-A0EE30415094}"/>
              </a:ext>
            </a:extLst>
          </p:cNvPr>
          <p:cNvSpPr txBox="1"/>
          <p:nvPr/>
        </p:nvSpPr>
        <p:spPr>
          <a:xfrm>
            <a:off x="461031" y="2325759"/>
            <a:ext cx="276822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 mimics +Vector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A80CADDE-071C-4E9C-A62D-9EB95DC0F748}"/>
              </a:ext>
            </a:extLst>
          </p:cNvPr>
          <p:cNvSpPr txBox="1"/>
          <p:nvPr/>
        </p:nvSpPr>
        <p:spPr>
          <a:xfrm>
            <a:off x="324435" y="4283441"/>
            <a:ext cx="31506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 mimics +p65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" name="直接箭头连接符 3">
            <a:extLst>
              <a:ext uri="{FF2B5EF4-FFF2-40B4-BE49-F238E27FC236}">
                <a16:creationId xmlns:a16="http://schemas.microsoft.com/office/drawing/2014/main" id="{98B73DB6-88E5-4670-9F69-47771F4AA8CB}"/>
              </a:ext>
            </a:extLst>
          </p:cNvPr>
          <p:cNvCxnSpPr/>
          <p:nvPr/>
        </p:nvCxnSpPr>
        <p:spPr>
          <a:xfrm>
            <a:off x="7493000" y="3259667"/>
            <a:ext cx="0" cy="321733"/>
          </a:xfrm>
          <a:prstGeom prst="straightConnector1">
            <a:avLst/>
          </a:prstGeom>
          <a:ln w="38100"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文本框 2">
            <a:extLst>
              <a:ext uri="{FF2B5EF4-FFF2-40B4-BE49-F238E27FC236}">
                <a16:creationId xmlns:a16="http://schemas.microsoft.com/office/drawing/2014/main" id="{9E1AA287-0A78-F9A1-E383-2D126C31EBF3}"/>
              </a:ext>
            </a:extLst>
          </p:cNvPr>
          <p:cNvSpPr txBox="1"/>
          <p:nvPr/>
        </p:nvSpPr>
        <p:spPr>
          <a:xfrm>
            <a:off x="3132287" y="1231043"/>
            <a:ext cx="15785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eat 1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32DA2C27-CE4E-E1D1-0AD5-A17156FE5609}"/>
              </a:ext>
            </a:extLst>
          </p:cNvPr>
          <p:cNvSpPr txBox="1"/>
          <p:nvPr/>
        </p:nvSpPr>
        <p:spPr>
          <a:xfrm>
            <a:off x="4992274" y="1231043"/>
            <a:ext cx="15785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eat 2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46CA7C3D-F3BF-3AB5-B907-88759C0C9E3C}"/>
              </a:ext>
            </a:extLst>
          </p:cNvPr>
          <p:cNvSpPr txBox="1"/>
          <p:nvPr/>
        </p:nvSpPr>
        <p:spPr>
          <a:xfrm>
            <a:off x="6750735" y="1231043"/>
            <a:ext cx="15785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eat 3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F6474A00-E1B2-ACC4-E30D-B4FA6B682AD0}"/>
              </a:ext>
            </a:extLst>
          </p:cNvPr>
          <p:cNvSpPr txBox="1"/>
          <p:nvPr/>
        </p:nvSpPr>
        <p:spPr>
          <a:xfrm>
            <a:off x="3229251" y="5188383"/>
            <a:ext cx="15785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eat 1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023395AF-731C-39DA-CBE7-497F23A06C53}"/>
              </a:ext>
            </a:extLst>
          </p:cNvPr>
          <p:cNvSpPr txBox="1"/>
          <p:nvPr/>
        </p:nvSpPr>
        <p:spPr>
          <a:xfrm>
            <a:off x="5089238" y="5188383"/>
            <a:ext cx="15785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eat 2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1AAB97FB-EA57-0892-837A-6B0093E41F00}"/>
              </a:ext>
            </a:extLst>
          </p:cNvPr>
          <p:cNvSpPr txBox="1"/>
          <p:nvPr/>
        </p:nvSpPr>
        <p:spPr>
          <a:xfrm>
            <a:off x="6847699" y="5188383"/>
            <a:ext cx="15785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eat 3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48784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4</TotalTime>
  <Words>47</Words>
  <Application>Microsoft Office PowerPoint</Application>
  <PresentationFormat>宽屏</PresentationFormat>
  <Paragraphs>18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ou yanrong</dc:creator>
  <cp:lastModifiedBy>yanrong zhou</cp:lastModifiedBy>
  <cp:revision>12</cp:revision>
  <dcterms:created xsi:type="dcterms:W3CDTF">2020-04-16T11:45:46Z</dcterms:created>
  <dcterms:modified xsi:type="dcterms:W3CDTF">2024-01-10T09:21:41Z</dcterms:modified>
</cp:coreProperties>
</file>